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7" r:id="rId2"/>
  </p:sldIdLst>
  <p:sldSz cx="15727363" cy="18927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61">
          <p15:clr>
            <a:srgbClr val="A4A3A4"/>
          </p15:clr>
        </p15:guide>
        <p15:guide id="2" pos="495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9" autoAdjust="0"/>
    <p:restoredTop sz="94660"/>
  </p:normalViewPr>
  <p:slideViewPr>
    <p:cSldViewPr snapToGrid="0">
      <p:cViewPr varScale="1">
        <p:scale>
          <a:sx n="23" d="100"/>
          <a:sy n="23" d="100"/>
        </p:scale>
        <p:origin x="876" y="64"/>
      </p:cViewPr>
      <p:guideLst>
        <p:guide orient="horz" pos="5961"/>
        <p:guide pos="495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79552" y="3097670"/>
            <a:ext cx="13368259" cy="6589666"/>
          </a:xfrm>
        </p:spPr>
        <p:txBody>
          <a:bodyPr anchor="b"/>
          <a:lstStyle>
            <a:lvl1pPr algn="ctr">
              <a:defRPr sz="103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65921" y="9941458"/>
            <a:ext cx="11795522" cy="4569827"/>
          </a:xfrm>
        </p:spPr>
        <p:txBody>
          <a:bodyPr/>
          <a:lstStyle>
            <a:lvl1pPr marL="0" indent="0" algn="ctr">
              <a:buNone/>
              <a:defRPr sz="4128"/>
            </a:lvl1pPr>
            <a:lvl2pPr marL="786384" indent="0" algn="ctr">
              <a:buNone/>
              <a:defRPr sz="3440"/>
            </a:lvl2pPr>
            <a:lvl3pPr marL="1572768" indent="0" algn="ctr">
              <a:buNone/>
              <a:defRPr sz="3096"/>
            </a:lvl3pPr>
            <a:lvl4pPr marL="2359152" indent="0" algn="ctr">
              <a:buNone/>
              <a:defRPr sz="2752"/>
            </a:lvl4pPr>
            <a:lvl5pPr marL="3145536" indent="0" algn="ctr">
              <a:buNone/>
              <a:defRPr sz="2752"/>
            </a:lvl5pPr>
            <a:lvl6pPr marL="3931920" indent="0" algn="ctr">
              <a:buNone/>
              <a:defRPr sz="2752"/>
            </a:lvl6pPr>
            <a:lvl7pPr marL="4718304" indent="0" algn="ctr">
              <a:buNone/>
              <a:defRPr sz="2752"/>
            </a:lvl7pPr>
            <a:lvl8pPr marL="5504688" indent="0" algn="ctr">
              <a:buNone/>
              <a:defRPr sz="2752"/>
            </a:lvl8pPr>
            <a:lvl9pPr marL="6291072" indent="0" algn="ctr">
              <a:buNone/>
              <a:defRPr sz="275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B9514-36C4-49CA-83F7-F7EA82368B20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CB9A9-263E-4709-A370-4A1F679ED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967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B9514-36C4-49CA-83F7-F7EA82368B20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CB9A9-263E-4709-A370-4A1F679ED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706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254895" y="1007728"/>
            <a:ext cx="3391213" cy="1604040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81257" y="1007728"/>
            <a:ext cx="9977046" cy="1604040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B9514-36C4-49CA-83F7-F7EA82368B20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CB9A9-263E-4709-A370-4A1F679ED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699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B9514-36C4-49CA-83F7-F7EA82368B20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CB9A9-263E-4709-A370-4A1F679ED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263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3066" y="4718802"/>
            <a:ext cx="13564851" cy="7873422"/>
          </a:xfrm>
        </p:spPr>
        <p:txBody>
          <a:bodyPr anchor="b"/>
          <a:lstStyle>
            <a:lvl1pPr>
              <a:defRPr sz="103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3066" y="12666710"/>
            <a:ext cx="13564851" cy="4140447"/>
          </a:xfrm>
        </p:spPr>
        <p:txBody>
          <a:bodyPr/>
          <a:lstStyle>
            <a:lvl1pPr marL="0" indent="0">
              <a:buNone/>
              <a:defRPr sz="4128">
                <a:solidFill>
                  <a:schemeClr val="tx1"/>
                </a:solidFill>
              </a:defRPr>
            </a:lvl1pPr>
            <a:lvl2pPr marL="786384" indent="0">
              <a:buNone/>
              <a:defRPr sz="3440">
                <a:solidFill>
                  <a:schemeClr val="tx1">
                    <a:tint val="75000"/>
                  </a:schemeClr>
                </a:solidFill>
              </a:defRPr>
            </a:lvl2pPr>
            <a:lvl3pPr marL="1572768" indent="0">
              <a:buNone/>
              <a:defRPr sz="3096">
                <a:solidFill>
                  <a:schemeClr val="tx1">
                    <a:tint val="75000"/>
                  </a:schemeClr>
                </a:solidFill>
              </a:defRPr>
            </a:lvl3pPr>
            <a:lvl4pPr marL="2359152" indent="0">
              <a:buNone/>
              <a:defRPr sz="2752">
                <a:solidFill>
                  <a:schemeClr val="tx1">
                    <a:tint val="75000"/>
                  </a:schemeClr>
                </a:solidFill>
              </a:defRPr>
            </a:lvl4pPr>
            <a:lvl5pPr marL="3145536" indent="0">
              <a:buNone/>
              <a:defRPr sz="2752">
                <a:solidFill>
                  <a:schemeClr val="tx1">
                    <a:tint val="75000"/>
                  </a:schemeClr>
                </a:solidFill>
              </a:defRPr>
            </a:lvl5pPr>
            <a:lvl6pPr marL="3931920" indent="0">
              <a:buNone/>
              <a:defRPr sz="2752">
                <a:solidFill>
                  <a:schemeClr val="tx1">
                    <a:tint val="75000"/>
                  </a:schemeClr>
                </a:solidFill>
              </a:defRPr>
            </a:lvl6pPr>
            <a:lvl7pPr marL="4718304" indent="0">
              <a:buNone/>
              <a:defRPr sz="2752">
                <a:solidFill>
                  <a:schemeClr val="tx1">
                    <a:tint val="75000"/>
                  </a:schemeClr>
                </a:solidFill>
              </a:defRPr>
            </a:lvl7pPr>
            <a:lvl8pPr marL="5504688" indent="0">
              <a:buNone/>
              <a:defRPr sz="2752">
                <a:solidFill>
                  <a:schemeClr val="tx1">
                    <a:tint val="75000"/>
                  </a:schemeClr>
                </a:solidFill>
              </a:defRPr>
            </a:lvl8pPr>
            <a:lvl9pPr marL="6291072" indent="0">
              <a:buNone/>
              <a:defRPr sz="275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B9514-36C4-49CA-83F7-F7EA82368B20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CB9A9-263E-4709-A370-4A1F679ED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932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81256" y="5038640"/>
            <a:ext cx="6684129" cy="120094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961978" y="5038640"/>
            <a:ext cx="6684129" cy="120094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B9514-36C4-49CA-83F7-F7EA82368B20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CB9A9-263E-4709-A370-4A1F679ED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605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3304" y="1007732"/>
            <a:ext cx="13564851" cy="365849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3306" y="4639932"/>
            <a:ext cx="6653411" cy="2273959"/>
          </a:xfrm>
        </p:spPr>
        <p:txBody>
          <a:bodyPr anchor="b"/>
          <a:lstStyle>
            <a:lvl1pPr marL="0" indent="0">
              <a:buNone/>
              <a:defRPr sz="4128" b="1"/>
            </a:lvl1pPr>
            <a:lvl2pPr marL="786384" indent="0">
              <a:buNone/>
              <a:defRPr sz="3440" b="1"/>
            </a:lvl2pPr>
            <a:lvl3pPr marL="1572768" indent="0">
              <a:buNone/>
              <a:defRPr sz="3096" b="1"/>
            </a:lvl3pPr>
            <a:lvl4pPr marL="2359152" indent="0">
              <a:buNone/>
              <a:defRPr sz="2752" b="1"/>
            </a:lvl4pPr>
            <a:lvl5pPr marL="3145536" indent="0">
              <a:buNone/>
              <a:defRPr sz="2752" b="1"/>
            </a:lvl5pPr>
            <a:lvl6pPr marL="3931920" indent="0">
              <a:buNone/>
              <a:defRPr sz="2752" b="1"/>
            </a:lvl6pPr>
            <a:lvl7pPr marL="4718304" indent="0">
              <a:buNone/>
              <a:defRPr sz="2752" b="1"/>
            </a:lvl7pPr>
            <a:lvl8pPr marL="5504688" indent="0">
              <a:buNone/>
              <a:defRPr sz="2752" b="1"/>
            </a:lvl8pPr>
            <a:lvl9pPr marL="6291072" indent="0">
              <a:buNone/>
              <a:defRPr sz="2752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83306" y="6913891"/>
            <a:ext cx="6653411" cy="1016929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961978" y="4639932"/>
            <a:ext cx="6686178" cy="2273959"/>
          </a:xfrm>
        </p:spPr>
        <p:txBody>
          <a:bodyPr anchor="b"/>
          <a:lstStyle>
            <a:lvl1pPr marL="0" indent="0">
              <a:buNone/>
              <a:defRPr sz="4128" b="1"/>
            </a:lvl1pPr>
            <a:lvl2pPr marL="786384" indent="0">
              <a:buNone/>
              <a:defRPr sz="3440" b="1"/>
            </a:lvl2pPr>
            <a:lvl3pPr marL="1572768" indent="0">
              <a:buNone/>
              <a:defRPr sz="3096" b="1"/>
            </a:lvl3pPr>
            <a:lvl4pPr marL="2359152" indent="0">
              <a:buNone/>
              <a:defRPr sz="2752" b="1"/>
            </a:lvl4pPr>
            <a:lvl5pPr marL="3145536" indent="0">
              <a:buNone/>
              <a:defRPr sz="2752" b="1"/>
            </a:lvl5pPr>
            <a:lvl6pPr marL="3931920" indent="0">
              <a:buNone/>
              <a:defRPr sz="2752" b="1"/>
            </a:lvl6pPr>
            <a:lvl7pPr marL="4718304" indent="0">
              <a:buNone/>
              <a:defRPr sz="2752" b="1"/>
            </a:lvl7pPr>
            <a:lvl8pPr marL="5504688" indent="0">
              <a:buNone/>
              <a:defRPr sz="2752" b="1"/>
            </a:lvl8pPr>
            <a:lvl9pPr marL="6291072" indent="0">
              <a:buNone/>
              <a:defRPr sz="2752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961978" y="6913891"/>
            <a:ext cx="6686178" cy="1016929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B9514-36C4-49CA-83F7-F7EA82368B20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CB9A9-263E-4709-A370-4A1F679ED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970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B9514-36C4-49CA-83F7-F7EA82368B20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CB9A9-263E-4709-A370-4A1F679ED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907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B9514-36C4-49CA-83F7-F7EA82368B20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CB9A9-263E-4709-A370-4A1F679ED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666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3305" y="1261851"/>
            <a:ext cx="5072484" cy="4416478"/>
          </a:xfrm>
        </p:spPr>
        <p:txBody>
          <a:bodyPr anchor="b"/>
          <a:lstStyle>
            <a:lvl1pPr>
              <a:defRPr sz="55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686178" y="2725251"/>
            <a:ext cx="7961978" cy="13450980"/>
          </a:xfrm>
        </p:spPr>
        <p:txBody>
          <a:bodyPr/>
          <a:lstStyle>
            <a:lvl1pPr>
              <a:defRPr sz="5504"/>
            </a:lvl1pPr>
            <a:lvl2pPr>
              <a:defRPr sz="4816"/>
            </a:lvl2pPr>
            <a:lvl3pPr>
              <a:defRPr sz="4128"/>
            </a:lvl3pPr>
            <a:lvl4pPr>
              <a:defRPr sz="3440"/>
            </a:lvl4pPr>
            <a:lvl5pPr>
              <a:defRPr sz="3440"/>
            </a:lvl5pPr>
            <a:lvl6pPr>
              <a:defRPr sz="3440"/>
            </a:lvl6pPr>
            <a:lvl7pPr>
              <a:defRPr sz="3440"/>
            </a:lvl7pPr>
            <a:lvl8pPr>
              <a:defRPr sz="3440"/>
            </a:lvl8pPr>
            <a:lvl9pPr>
              <a:defRPr sz="344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83305" y="5678329"/>
            <a:ext cx="5072484" cy="10519807"/>
          </a:xfrm>
        </p:spPr>
        <p:txBody>
          <a:bodyPr/>
          <a:lstStyle>
            <a:lvl1pPr marL="0" indent="0">
              <a:buNone/>
              <a:defRPr sz="2752"/>
            </a:lvl1pPr>
            <a:lvl2pPr marL="786384" indent="0">
              <a:buNone/>
              <a:defRPr sz="2408"/>
            </a:lvl2pPr>
            <a:lvl3pPr marL="1572768" indent="0">
              <a:buNone/>
              <a:defRPr sz="2064"/>
            </a:lvl3pPr>
            <a:lvl4pPr marL="2359152" indent="0">
              <a:buNone/>
              <a:defRPr sz="1720"/>
            </a:lvl4pPr>
            <a:lvl5pPr marL="3145536" indent="0">
              <a:buNone/>
              <a:defRPr sz="1720"/>
            </a:lvl5pPr>
            <a:lvl6pPr marL="3931920" indent="0">
              <a:buNone/>
              <a:defRPr sz="1720"/>
            </a:lvl6pPr>
            <a:lvl7pPr marL="4718304" indent="0">
              <a:buNone/>
              <a:defRPr sz="1720"/>
            </a:lvl7pPr>
            <a:lvl8pPr marL="5504688" indent="0">
              <a:buNone/>
              <a:defRPr sz="1720"/>
            </a:lvl8pPr>
            <a:lvl9pPr marL="6291072" indent="0">
              <a:buNone/>
              <a:defRPr sz="172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B9514-36C4-49CA-83F7-F7EA82368B20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CB9A9-263E-4709-A370-4A1F679ED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89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3305" y="1261851"/>
            <a:ext cx="5072484" cy="4416478"/>
          </a:xfrm>
        </p:spPr>
        <p:txBody>
          <a:bodyPr anchor="b"/>
          <a:lstStyle>
            <a:lvl1pPr>
              <a:defRPr sz="55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86178" y="2725251"/>
            <a:ext cx="7961978" cy="13450980"/>
          </a:xfrm>
        </p:spPr>
        <p:txBody>
          <a:bodyPr anchor="t"/>
          <a:lstStyle>
            <a:lvl1pPr marL="0" indent="0">
              <a:buNone/>
              <a:defRPr sz="5504"/>
            </a:lvl1pPr>
            <a:lvl2pPr marL="786384" indent="0">
              <a:buNone/>
              <a:defRPr sz="4816"/>
            </a:lvl2pPr>
            <a:lvl3pPr marL="1572768" indent="0">
              <a:buNone/>
              <a:defRPr sz="4128"/>
            </a:lvl3pPr>
            <a:lvl4pPr marL="2359152" indent="0">
              <a:buNone/>
              <a:defRPr sz="3440"/>
            </a:lvl4pPr>
            <a:lvl5pPr marL="3145536" indent="0">
              <a:buNone/>
              <a:defRPr sz="3440"/>
            </a:lvl5pPr>
            <a:lvl6pPr marL="3931920" indent="0">
              <a:buNone/>
              <a:defRPr sz="3440"/>
            </a:lvl6pPr>
            <a:lvl7pPr marL="4718304" indent="0">
              <a:buNone/>
              <a:defRPr sz="3440"/>
            </a:lvl7pPr>
            <a:lvl8pPr marL="5504688" indent="0">
              <a:buNone/>
              <a:defRPr sz="3440"/>
            </a:lvl8pPr>
            <a:lvl9pPr marL="6291072" indent="0">
              <a:buNone/>
              <a:defRPr sz="344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83305" y="5678329"/>
            <a:ext cx="5072484" cy="10519807"/>
          </a:xfrm>
        </p:spPr>
        <p:txBody>
          <a:bodyPr/>
          <a:lstStyle>
            <a:lvl1pPr marL="0" indent="0">
              <a:buNone/>
              <a:defRPr sz="2752"/>
            </a:lvl1pPr>
            <a:lvl2pPr marL="786384" indent="0">
              <a:buNone/>
              <a:defRPr sz="2408"/>
            </a:lvl2pPr>
            <a:lvl3pPr marL="1572768" indent="0">
              <a:buNone/>
              <a:defRPr sz="2064"/>
            </a:lvl3pPr>
            <a:lvl4pPr marL="2359152" indent="0">
              <a:buNone/>
              <a:defRPr sz="1720"/>
            </a:lvl4pPr>
            <a:lvl5pPr marL="3145536" indent="0">
              <a:buNone/>
              <a:defRPr sz="1720"/>
            </a:lvl5pPr>
            <a:lvl6pPr marL="3931920" indent="0">
              <a:buNone/>
              <a:defRPr sz="1720"/>
            </a:lvl6pPr>
            <a:lvl7pPr marL="4718304" indent="0">
              <a:buNone/>
              <a:defRPr sz="1720"/>
            </a:lvl7pPr>
            <a:lvl8pPr marL="5504688" indent="0">
              <a:buNone/>
              <a:defRPr sz="1720"/>
            </a:lvl8pPr>
            <a:lvl9pPr marL="6291072" indent="0">
              <a:buNone/>
              <a:defRPr sz="172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B9514-36C4-49CA-83F7-F7EA82368B20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4CB9A9-263E-4709-A370-4A1F679ED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207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81256" y="1007732"/>
            <a:ext cx="13564851" cy="365849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1256" y="5038640"/>
            <a:ext cx="13564851" cy="120094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81256" y="17543236"/>
            <a:ext cx="3538657" cy="10077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CB9514-36C4-49CA-83F7-F7EA82368B20}" type="datetimeFigureOut">
              <a:rPr lang="en-US" smtClean="0"/>
              <a:t>11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209689" y="17543236"/>
            <a:ext cx="5307985" cy="10077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107450" y="17543236"/>
            <a:ext cx="3538657" cy="10077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4CB9A9-263E-4709-A370-4A1F679EDC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495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572768" rtl="0" eaLnBrk="1" latinLnBrk="0" hangingPunct="1">
        <a:lnSpc>
          <a:spcPct val="90000"/>
        </a:lnSpc>
        <a:spcBef>
          <a:spcPct val="0"/>
        </a:spcBef>
        <a:buNone/>
        <a:defRPr sz="756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93192" indent="-393192" algn="l" defTabSz="1572768" rtl="0" eaLnBrk="1" latinLnBrk="0" hangingPunct="1">
        <a:lnSpc>
          <a:spcPct val="90000"/>
        </a:lnSpc>
        <a:spcBef>
          <a:spcPts val="1720"/>
        </a:spcBef>
        <a:buFont typeface="Arial" panose="020B0604020202020204" pitchFamily="34" charset="0"/>
        <a:buChar char="•"/>
        <a:defRPr sz="4816" kern="1200">
          <a:solidFill>
            <a:schemeClr val="tx1"/>
          </a:solidFill>
          <a:latin typeface="+mn-lt"/>
          <a:ea typeface="+mn-ea"/>
          <a:cs typeface="+mn-cs"/>
        </a:defRPr>
      </a:lvl1pPr>
      <a:lvl2pPr marL="1179576" indent="-393192" algn="l" defTabSz="1572768" rtl="0" eaLnBrk="1" latinLnBrk="0" hangingPunct="1">
        <a:lnSpc>
          <a:spcPct val="90000"/>
        </a:lnSpc>
        <a:spcBef>
          <a:spcPts val="860"/>
        </a:spcBef>
        <a:buFont typeface="Arial" panose="020B0604020202020204" pitchFamily="34" charset="0"/>
        <a:buChar char="•"/>
        <a:defRPr sz="4128" kern="1200">
          <a:solidFill>
            <a:schemeClr val="tx1"/>
          </a:solidFill>
          <a:latin typeface="+mn-lt"/>
          <a:ea typeface="+mn-ea"/>
          <a:cs typeface="+mn-cs"/>
        </a:defRPr>
      </a:lvl2pPr>
      <a:lvl3pPr marL="1965960" indent="-393192" algn="l" defTabSz="1572768" rtl="0" eaLnBrk="1" latinLnBrk="0" hangingPunct="1">
        <a:lnSpc>
          <a:spcPct val="90000"/>
        </a:lnSpc>
        <a:spcBef>
          <a:spcPts val="860"/>
        </a:spcBef>
        <a:buFont typeface="Arial" panose="020B0604020202020204" pitchFamily="34" charset="0"/>
        <a:buChar char="•"/>
        <a:defRPr sz="3440" kern="1200">
          <a:solidFill>
            <a:schemeClr val="tx1"/>
          </a:solidFill>
          <a:latin typeface="+mn-lt"/>
          <a:ea typeface="+mn-ea"/>
          <a:cs typeface="+mn-cs"/>
        </a:defRPr>
      </a:lvl3pPr>
      <a:lvl4pPr marL="2752344" indent="-393192" algn="l" defTabSz="1572768" rtl="0" eaLnBrk="1" latinLnBrk="0" hangingPunct="1">
        <a:lnSpc>
          <a:spcPct val="90000"/>
        </a:lnSpc>
        <a:spcBef>
          <a:spcPts val="860"/>
        </a:spcBef>
        <a:buFont typeface="Arial" panose="020B0604020202020204" pitchFamily="34" charset="0"/>
        <a:buChar char="•"/>
        <a:defRPr sz="3096" kern="1200">
          <a:solidFill>
            <a:schemeClr val="tx1"/>
          </a:solidFill>
          <a:latin typeface="+mn-lt"/>
          <a:ea typeface="+mn-ea"/>
          <a:cs typeface="+mn-cs"/>
        </a:defRPr>
      </a:lvl4pPr>
      <a:lvl5pPr marL="3538728" indent="-393192" algn="l" defTabSz="1572768" rtl="0" eaLnBrk="1" latinLnBrk="0" hangingPunct="1">
        <a:lnSpc>
          <a:spcPct val="90000"/>
        </a:lnSpc>
        <a:spcBef>
          <a:spcPts val="860"/>
        </a:spcBef>
        <a:buFont typeface="Arial" panose="020B0604020202020204" pitchFamily="34" charset="0"/>
        <a:buChar char="•"/>
        <a:defRPr sz="3096" kern="1200">
          <a:solidFill>
            <a:schemeClr val="tx1"/>
          </a:solidFill>
          <a:latin typeface="+mn-lt"/>
          <a:ea typeface="+mn-ea"/>
          <a:cs typeface="+mn-cs"/>
        </a:defRPr>
      </a:lvl5pPr>
      <a:lvl6pPr marL="4325112" indent="-393192" algn="l" defTabSz="1572768" rtl="0" eaLnBrk="1" latinLnBrk="0" hangingPunct="1">
        <a:lnSpc>
          <a:spcPct val="90000"/>
        </a:lnSpc>
        <a:spcBef>
          <a:spcPts val="860"/>
        </a:spcBef>
        <a:buFont typeface="Arial" panose="020B0604020202020204" pitchFamily="34" charset="0"/>
        <a:buChar char="•"/>
        <a:defRPr sz="3096" kern="1200">
          <a:solidFill>
            <a:schemeClr val="tx1"/>
          </a:solidFill>
          <a:latin typeface="+mn-lt"/>
          <a:ea typeface="+mn-ea"/>
          <a:cs typeface="+mn-cs"/>
        </a:defRPr>
      </a:lvl6pPr>
      <a:lvl7pPr marL="5111496" indent="-393192" algn="l" defTabSz="1572768" rtl="0" eaLnBrk="1" latinLnBrk="0" hangingPunct="1">
        <a:lnSpc>
          <a:spcPct val="90000"/>
        </a:lnSpc>
        <a:spcBef>
          <a:spcPts val="860"/>
        </a:spcBef>
        <a:buFont typeface="Arial" panose="020B0604020202020204" pitchFamily="34" charset="0"/>
        <a:buChar char="•"/>
        <a:defRPr sz="3096" kern="1200">
          <a:solidFill>
            <a:schemeClr val="tx1"/>
          </a:solidFill>
          <a:latin typeface="+mn-lt"/>
          <a:ea typeface="+mn-ea"/>
          <a:cs typeface="+mn-cs"/>
        </a:defRPr>
      </a:lvl7pPr>
      <a:lvl8pPr marL="5897880" indent="-393192" algn="l" defTabSz="1572768" rtl="0" eaLnBrk="1" latinLnBrk="0" hangingPunct="1">
        <a:lnSpc>
          <a:spcPct val="90000"/>
        </a:lnSpc>
        <a:spcBef>
          <a:spcPts val="860"/>
        </a:spcBef>
        <a:buFont typeface="Arial" panose="020B0604020202020204" pitchFamily="34" charset="0"/>
        <a:buChar char="•"/>
        <a:defRPr sz="3096" kern="1200">
          <a:solidFill>
            <a:schemeClr val="tx1"/>
          </a:solidFill>
          <a:latin typeface="+mn-lt"/>
          <a:ea typeface="+mn-ea"/>
          <a:cs typeface="+mn-cs"/>
        </a:defRPr>
      </a:lvl8pPr>
      <a:lvl9pPr marL="6684264" indent="-393192" algn="l" defTabSz="1572768" rtl="0" eaLnBrk="1" latinLnBrk="0" hangingPunct="1">
        <a:lnSpc>
          <a:spcPct val="90000"/>
        </a:lnSpc>
        <a:spcBef>
          <a:spcPts val="860"/>
        </a:spcBef>
        <a:buFont typeface="Arial" panose="020B0604020202020204" pitchFamily="34" charset="0"/>
        <a:buChar char="•"/>
        <a:defRPr sz="309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72768" rtl="0" eaLnBrk="1" latinLnBrk="0" hangingPunct="1">
        <a:defRPr sz="3096" kern="1200">
          <a:solidFill>
            <a:schemeClr val="tx1"/>
          </a:solidFill>
          <a:latin typeface="+mn-lt"/>
          <a:ea typeface="+mn-ea"/>
          <a:cs typeface="+mn-cs"/>
        </a:defRPr>
      </a:lvl1pPr>
      <a:lvl2pPr marL="786384" algn="l" defTabSz="1572768" rtl="0" eaLnBrk="1" latinLnBrk="0" hangingPunct="1">
        <a:defRPr sz="3096" kern="1200">
          <a:solidFill>
            <a:schemeClr val="tx1"/>
          </a:solidFill>
          <a:latin typeface="+mn-lt"/>
          <a:ea typeface="+mn-ea"/>
          <a:cs typeface="+mn-cs"/>
        </a:defRPr>
      </a:lvl2pPr>
      <a:lvl3pPr marL="1572768" algn="l" defTabSz="1572768" rtl="0" eaLnBrk="1" latinLnBrk="0" hangingPunct="1">
        <a:defRPr sz="3096" kern="1200">
          <a:solidFill>
            <a:schemeClr val="tx1"/>
          </a:solidFill>
          <a:latin typeface="+mn-lt"/>
          <a:ea typeface="+mn-ea"/>
          <a:cs typeface="+mn-cs"/>
        </a:defRPr>
      </a:lvl3pPr>
      <a:lvl4pPr marL="2359152" algn="l" defTabSz="1572768" rtl="0" eaLnBrk="1" latinLnBrk="0" hangingPunct="1">
        <a:defRPr sz="3096" kern="1200">
          <a:solidFill>
            <a:schemeClr val="tx1"/>
          </a:solidFill>
          <a:latin typeface="+mn-lt"/>
          <a:ea typeface="+mn-ea"/>
          <a:cs typeface="+mn-cs"/>
        </a:defRPr>
      </a:lvl4pPr>
      <a:lvl5pPr marL="3145536" algn="l" defTabSz="1572768" rtl="0" eaLnBrk="1" latinLnBrk="0" hangingPunct="1">
        <a:defRPr sz="3096" kern="1200">
          <a:solidFill>
            <a:schemeClr val="tx1"/>
          </a:solidFill>
          <a:latin typeface="+mn-lt"/>
          <a:ea typeface="+mn-ea"/>
          <a:cs typeface="+mn-cs"/>
        </a:defRPr>
      </a:lvl5pPr>
      <a:lvl6pPr marL="3931920" algn="l" defTabSz="1572768" rtl="0" eaLnBrk="1" latinLnBrk="0" hangingPunct="1">
        <a:defRPr sz="3096" kern="1200">
          <a:solidFill>
            <a:schemeClr val="tx1"/>
          </a:solidFill>
          <a:latin typeface="+mn-lt"/>
          <a:ea typeface="+mn-ea"/>
          <a:cs typeface="+mn-cs"/>
        </a:defRPr>
      </a:lvl6pPr>
      <a:lvl7pPr marL="4718304" algn="l" defTabSz="1572768" rtl="0" eaLnBrk="1" latinLnBrk="0" hangingPunct="1">
        <a:defRPr sz="3096" kern="1200">
          <a:solidFill>
            <a:schemeClr val="tx1"/>
          </a:solidFill>
          <a:latin typeface="+mn-lt"/>
          <a:ea typeface="+mn-ea"/>
          <a:cs typeface="+mn-cs"/>
        </a:defRPr>
      </a:lvl7pPr>
      <a:lvl8pPr marL="5504688" algn="l" defTabSz="1572768" rtl="0" eaLnBrk="1" latinLnBrk="0" hangingPunct="1">
        <a:defRPr sz="3096" kern="1200">
          <a:solidFill>
            <a:schemeClr val="tx1"/>
          </a:solidFill>
          <a:latin typeface="+mn-lt"/>
          <a:ea typeface="+mn-ea"/>
          <a:cs typeface="+mn-cs"/>
        </a:defRPr>
      </a:lvl8pPr>
      <a:lvl9pPr marL="6291072" algn="l" defTabSz="1572768" rtl="0" eaLnBrk="1" latinLnBrk="0" hangingPunct="1">
        <a:defRPr sz="309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-1378152" y="-3352039"/>
            <a:ext cx="9572977" cy="1005547"/>
          </a:xfrm>
          <a:prstGeom prst="rect">
            <a:avLst/>
          </a:prstGeom>
          <a:noFill/>
        </p:spPr>
        <p:txBody>
          <a:bodyPr wrap="square" lIns="225125" tIns="112561" rIns="225125" bIns="112561" rtlCol="0">
            <a:spAutoFit/>
          </a:bodyPr>
          <a:lstStyle/>
          <a:p>
            <a:r>
              <a:rPr lang="en-US" sz="5057" b="1" u="sng" dirty="0">
                <a:solidFill>
                  <a:srgbClr val="FF0000"/>
                </a:solidFill>
                <a:latin typeface="+mj-lt"/>
              </a:rPr>
              <a:t>New- Supplementary Table 1</a:t>
            </a:r>
          </a:p>
        </p:txBody>
      </p:sp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9491676"/>
              </p:ext>
            </p:extLst>
          </p:nvPr>
        </p:nvGraphicFramePr>
        <p:xfrm>
          <a:off x="1720215" y="314197"/>
          <a:ext cx="11961788" cy="17289525"/>
        </p:xfrm>
        <a:graphic>
          <a:graphicData uri="http://schemas.openxmlformats.org/drawingml/2006/table">
            <a:tbl>
              <a:tblPr bandRow="1">
                <a:tableStyleId>{9D7B26C5-4107-4FEC-AEDC-1716B250A1EF}</a:tableStyleId>
              </a:tblPr>
              <a:tblGrid>
                <a:gridCol w="292005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33677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2412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26283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0082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3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Line</a:t>
                      </a:r>
                      <a:endParaRPr lang="en-US" sz="3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  <a:alpha val="20000"/>
                      </a:schemeClr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3500" b="1" dirty="0"/>
                        <a:t>EC50 (</a:t>
                      </a:r>
                      <a:r>
                        <a:rPr lang="en-US" sz="3500" b="1" dirty="0" err="1"/>
                        <a:t>uM</a:t>
                      </a:r>
                      <a:r>
                        <a:rPr lang="en-US" sz="3500" b="1" dirty="0"/>
                        <a:t>)</a:t>
                      </a: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  <a:alpha val="2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7803" marR="7803" marT="780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  <a:alpha val="2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7803" marR="7803" marT="780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  <a:alpha val="2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7803" marR="7803" marT="780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08431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brutinib</a:t>
                      </a:r>
                      <a:endParaRPr lang="en-US" sz="3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O/</a:t>
                      </a:r>
                    </a:p>
                    <a:p>
                      <a:pPr algn="ctr" fontAlgn="b"/>
                      <a:r>
                        <a:rPr lang="en-US" sz="3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-4059</a:t>
                      </a:r>
                      <a:endParaRPr lang="en-US" sz="3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ELA</a:t>
                      </a:r>
                      <a:endParaRPr lang="en-US" sz="3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-649443</a:t>
                      </a:r>
                      <a:endParaRPr lang="en-US" sz="3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naval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B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HH-2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5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-18</a:t>
                      </a:r>
                      <a:endParaRPr lang="en-US" sz="3500" b="0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72356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rpas422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</a:t>
                      </a:r>
                      <a:endParaRPr lang="en-US" sz="3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-DHL-1</a:t>
                      </a:r>
                      <a:endParaRPr lang="en-US" sz="35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9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6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-DUL-1</a:t>
                      </a:r>
                      <a:endParaRPr lang="en-US" sz="35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</a:t>
                      </a:r>
                      <a:endParaRPr lang="en-US" sz="3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4</a:t>
                      </a:r>
                      <a:endParaRPr lang="en-US" sz="3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lang="en-US" sz="3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I-LY10</a:t>
                      </a:r>
                      <a:endParaRPr lang="en-US" sz="3500" b="0" i="0" u="none" strike="noStrike" dirty="0">
                        <a:solidFill>
                          <a:srgbClr val="00B0F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5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I-LY19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I-LY3</a:t>
                      </a:r>
                      <a:endParaRPr lang="en-US" sz="3500" b="0" i="0" u="none" strike="noStrike" dirty="0">
                        <a:solidFill>
                          <a:srgbClr val="00B0F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I-LY4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en-US" sz="3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2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8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I-LY7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eiffer</a:t>
                      </a:r>
                      <a:endParaRPr lang="en-US" sz="3500" b="0" i="0" u="none" strike="noStrike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</a:t>
                      </a:r>
                      <a:endParaRPr lang="en-US" sz="3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  <a:endParaRPr lang="en-US" sz="3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-1</a:t>
                      </a:r>
                      <a:endParaRPr lang="en-US" sz="3500" b="0" i="0" u="none" strike="noStrike" dirty="0">
                        <a:solidFill>
                          <a:srgbClr val="00B0F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L</a:t>
                      </a:r>
                      <a:endParaRPr lang="en-US" sz="3500" b="0" i="0" u="none" strike="noStrike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</a:t>
                      </a:r>
                      <a:endParaRPr lang="en-US" sz="3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</a:t>
                      </a:r>
                      <a:endParaRPr lang="en-US" sz="3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7</a:t>
                      </a:r>
                      <a:endParaRPr lang="en-US" sz="3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5230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-DHL-10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518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-DHL16</a:t>
                      </a:r>
                      <a:endParaRPr lang="en-US" sz="3500" b="0" i="0" u="none" strike="noStrike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3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-DHL-2</a:t>
                      </a:r>
                      <a:endParaRPr lang="en-US" sz="3500" b="0" i="0" u="none" strike="noStrike" dirty="0">
                        <a:solidFill>
                          <a:srgbClr val="00B0F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7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-DHL-4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</a:t>
                      </a:r>
                      <a:endParaRPr lang="en-US" sz="3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-DHL-5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-DHL-6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2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-DHL-8</a:t>
                      </a:r>
                      <a:endParaRPr lang="en-US" sz="3500" b="0" i="0" u="none" strike="noStrike" dirty="0">
                        <a:solidFill>
                          <a:srgbClr val="00B0F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D-8</a:t>
                      </a:r>
                      <a:endParaRPr lang="en-US" sz="3500" b="0" i="0" u="none" strike="noStrike" dirty="0">
                        <a:solidFill>
                          <a:srgbClr val="00B0F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7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0.0006</a:t>
                      </a:r>
                      <a:endParaRPr lang="en-US" sz="35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ledo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2932</a:t>
                      </a:r>
                      <a:endParaRPr lang="en-US" sz="3500" b="0" i="0" u="none" strike="noStrike" dirty="0">
                        <a:solidFill>
                          <a:srgbClr val="00B0F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1</a:t>
                      </a:r>
                      <a:endParaRPr lang="en-US" sz="3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6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-2973</a:t>
                      </a:r>
                      <a:endParaRPr lang="en-US" sz="3500" b="0" i="0" u="none" strike="noStrike" dirty="0">
                        <a:solidFill>
                          <a:srgbClr val="C0504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554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SU-FSCCL</a:t>
                      </a:r>
                      <a:endParaRPr lang="en-US" sz="3500" b="0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4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en-US" sz="3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4661" marR="24661" marT="24661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338020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30</Words>
  <Application>Microsoft Office PowerPoint</Application>
  <PresentationFormat>Custom</PresentationFormat>
  <Paragraphs>1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wa Wandzioch</dc:creator>
  <cp:lastModifiedBy>Meryl Gersh</cp:lastModifiedBy>
  <cp:revision>3</cp:revision>
  <dcterms:created xsi:type="dcterms:W3CDTF">2016-11-16T02:02:05Z</dcterms:created>
  <dcterms:modified xsi:type="dcterms:W3CDTF">2016-11-22T14:39:56Z</dcterms:modified>
</cp:coreProperties>
</file>